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77A13F-74F1-D24B-B821-5E9E11C853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31EBB8A-AB72-0D42-9E7A-0D9C801D5C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7F8B03-E289-7040-B5FB-0A12E4994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C91D5F-306B-5840-A07A-8564CDBEC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0643AE-7B87-8644-84F8-B56BA6963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069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3553C6-6FF7-6F42-9A9B-71CBECAAA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869F368-DD06-9049-A96F-8BECF5E40A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12E8CF-31FF-434A-99D8-6BFEA6BDE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627E33-2114-244A-A396-2A1FEE9C8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48AE1D-B589-C244-971E-4F8E86067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907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3B340E6-22A0-F24A-9E0D-38C78B45E9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9E5316-C3FC-774E-89A8-A033A8F0D1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EB4400-088D-1C41-B2F9-F37A4033C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4E9093-9D07-D64A-8F13-07A450B4A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2A6761-0F2B-CA47-925D-8AC8BB441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295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8AA717-8C2F-0D47-BC4B-359567A96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F69352-854C-2C4E-8F0B-2326CF67D1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6573B4-9200-6947-87D7-95FFD64B0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ABFC0A-48F5-D34C-A79F-399CF6A8C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38AC85-04A9-FA43-8BC4-1CD8E6694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6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F92387-2C41-C040-A49B-4BBFAA2B0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9FFEA3D-CBF4-1C43-B523-92655399F3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AF07C7-1784-874F-817C-1EBD811A3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A9DB20-12DC-AC41-A554-83B571B8D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319AD5-2820-FA49-AF91-AFCEA878A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812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147D69-7AFF-E142-875C-80A1586AC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0B06879-4007-A54F-8DEF-28571A714A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AEE836-5F59-C849-8E4E-614F70622E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211266-16C6-2A4A-9E15-F92DB0F27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28D87E2-A4F1-F24C-A620-A6C579EED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DF19B01-EF83-6947-8893-8B3B45F95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332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88E0E4-042F-0042-B70B-8B2DBAA61F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2BC564-E01B-3541-9CF1-BEEF85665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BA67D06-3C50-FF46-8C17-16FC21DEC6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8721D2B-A982-B34E-8616-93A141796E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D1033C5-911C-4540-B8F2-994FF3140F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70FF710-5DD4-B34E-BC62-52E3325CD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FD32F94-7F40-DC4C-8068-0C0BFA04F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922505E-FCEE-124F-9B7B-7E727F08C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434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F111C1-7E6E-8D49-9E06-D0BA8A1190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56FBA1C-4350-4F49-B83A-8C005E106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FFA4410-7A41-FC48-AB39-D70572439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00E83B-E632-0F4F-A5A4-45BF82090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9195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F77A648-3283-654A-B488-F2B106DE18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11712B7-C5F2-3E43-9231-C07FDB0C7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13D337-2A37-9442-B918-5AEA4C3B3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012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2A60-E24F-B24C-9549-59D6DF4C9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B3B4C5-4609-DF42-BEF0-58E3BA96FB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819A097-420A-DE42-AC5F-2A31E50AE7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D270BF-8578-D642-BAC9-0E77ED71F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0A2B15-F86E-7242-877F-A985AB6CB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88683F-E410-2747-9768-C2B14281F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573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900060-775D-0446-BBEA-EEF049360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8D40ABE-9CE6-4047-94FF-A846332EE7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FF21E4B-30C1-8746-B6BC-8469BE49F0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0B137A-D370-F34B-89FF-F04BC9BC9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681077C-532D-0240-AFC6-392639CCB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006C65-1BD0-914D-8EB8-2C7512AA9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69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BC1E00-9A65-824C-9522-FDB2F0F7FC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2CB7BAE-4F3C-A84D-8874-6A1CC570B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7897042-3CDD-6D4C-A7E2-0AE7BC2E82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D2547-D20A-814C-ABD4-357ECBD96EF8}" type="datetimeFigureOut">
              <a:rPr kumimoji="1" lang="ja-JP" altLang="en-US" smtClean="0"/>
              <a:t>2022/3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9D25D-0D4D-DB4F-8C6F-220770B47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93D4F4-AA72-7341-B7B8-7474F1B8A8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6D6C1-C245-4D40-A027-3DA79374B1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996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37AFAAE-750F-2F49-B61F-F68A41D82B93}"/>
              </a:ext>
            </a:extLst>
          </p:cNvPr>
          <p:cNvSpPr txBox="1"/>
          <p:nvPr/>
        </p:nvSpPr>
        <p:spPr>
          <a:xfrm>
            <a:off x="180476" y="882842"/>
            <a:ext cx="15301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Helvetica" pitchFamily="2" charset="0"/>
              </a:rPr>
              <a:t>(a) Task 1</a:t>
            </a:r>
            <a:endParaRPr kumimoji="1" lang="ja-JP" altLang="en-US" sz="2400">
              <a:latin typeface="Helvetica" pitchFamily="2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1F6E8B14-304B-6E43-AEB6-6E22683D50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983" y="1339563"/>
            <a:ext cx="5841383" cy="502792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E980D3C-B54F-CC4B-B9DD-ED5B2CBFCADD}"/>
              </a:ext>
            </a:extLst>
          </p:cNvPr>
          <p:cNvSpPr txBox="1"/>
          <p:nvPr/>
        </p:nvSpPr>
        <p:spPr>
          <a:xfrm>
            <a:off x="6170141" y="882842"/>
            <a:ext cx="15301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Helvetica" pitchFamily="2" charset="0"/>
              </a:rPr>
              <a:t>(b) Task 3</a:t>
            </a:r>
            <a:endParaRPr kumimoji="1" lang="ja-JP" altLang="en-US" sz="2400">
              <a:latin typeface="Helvetica" pitchFamily="2" charset="0"/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436A3EDC-61B2-3F44-BC8D-91D3C58EC4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0141" y="1339562"/>
            <a:ext cx="5841383" cy="501913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19526CA-228E-8440-BF4D-D491FCAE1995}"/>
              </a:ext>
            </a:extLst>
          </p:cNvPr>
          <p:cNvSpPr txBox="1"/>
          <p:nvPr/>
        </p:nvSpPr>
        <p:spPr>
          <a:xfrm>
            <a:off x="165983" y="151955"/>
            <a:ext cx="7875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>
                <a:latin typeface="Helvetica" pitchFamily="2" charset="0"/>
              </a:rPr>
              <a:t>Supplementary figure </a:t>
            </a:r>
            <a:r>
              <a:rPr lang="en-US" altLang="ja-JP" sz="1600" dirty="0">
                <a:latin typeface="Helvetica" pitchFamily="2" charset="0"/>
              </a:rPr>
              <a:t>2</a:t>
            </a:r>
            <a:r>
              <a:rPr lang="en-US" altLang="ja-JP" sz="1600">
                <a:latin typeface="Helvetica" pitchFamily="2" charset="0"/>
              </a:rPr>
              <a:t>.  </a:t>
            </a:r>
            <a:r>
              <a:rPr lang="en-US" altLang="ja-JP" sz="1600" dirty="0">
                <a:latin typeface="Helvetica" pitchFamily="2" charset="0"/>
              </a:rPr>
              <a:t>Scatterplots of GOALS scores assessed by the two experts</a:t>
            </a:r>
            <a:endParaRPr kumimoji="1" lang="ja-JP" altLang="en-US" sz="16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1918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4</TotalTime>
  <Words>23</Words>
  <Application>Microsoft Macintosh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11</cp:revision>
  <dcterms:created xsi:type="dcterms:W3CDTF">2021-01-02T07:10:52Z</dcterms:created>
  <dcterms:modified xsi:type="dcterms:W3CDTF">2022-03-15T12:47:38Z</dcterms:modified>
</cp:coreProperties>
</file>